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796"/>
    <p:restoredTop sz="94629"/>
  </p:normalViewPr>
  <p:slideViewPr>
    <p:cSldViewPr snapToGrid="0" snapToObjects="1">
      <p:cViewPr varScale="1">
        <p:scale>
          <a:sx n="108" d="100"/>
          <a:sy n="108" d="100"/>
        </p:scale>
        <p:origin x="175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062905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8283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370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39204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513745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5018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762094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8559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243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131404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4750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81821A-3A53-374A-812F-172680836117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5B0F3-B472-CC40-AAE9-774974AE4D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2046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a 3">
            <a:extLst>
              <a:ext uri="{FF2B5EF4-FFF2-40B4-BE49-F238E27FC236}">
                <a16:creationId xmlns:a16="http://schemas.microsoft.com/office/drawing/2014/main" id="{199EDBE5-8D7C-1F44-BB43-E8C8659B06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19476745"/>
              </p:ext>
            </p:extLst>
          </p:nvPr>
        </p:nvGraphicFramePr>
        <p:xfrm>
          <a:off x="3534360" y="1560262"/>
          <a:ext cx="3237646" cy="89131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18823">
                  <a:extLst>
                    <a:ext uri="{9D8B030D-6E8A-4147-A177-3AD203B41FA5}">
                      <a16:colId xmlns:a16="http://schemas.microsoft.com/office/drawing/2014/main" val="2907900482"/>
                    </a:ext>
                  </a:extLst>
                </a:gridCol>
                <a:gridCol w="1618823">
                  <a:extLst>
                    <a:ext uri="{9D8B030D-6E8A-4147-A177-3AD203B41FA5}">
                      <a16:colId xmlns:a16="http://schemas.microsoft.com/office/drawing/2014/main" val="2535064530"/>
                    </a:ext>
                  </a:extLst>
                </a:gridCol>
              </a:tblGrid>
              <a:tr h="44565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14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9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5272359"/>
                  </a:ext>
                </a:extLst>
              </a:tr>
              <a:tr h="44565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6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2400017"/>
                  </a:ext>
                </a:extLst>
              </a:tr>
            </a:tbl>
          </a:graphicData>
        </a:graphic>
      </p:graphicFrame>
      <p:sp>
        <p:nvSpPr>
          <p:cNvPr id="4" name="CuadroTexto 3">
            <a:extLst>
              <a:ext uri="{FF2B5EF4-FFF2-40B4-BE49-F238E27FC236}">
                <a16:creationId xmlns:a16="http://schemas.microsoft.com/office/drawing/2014/main" id="{B42779D5-AF31-4B46-A1EF-4DE2C45C3555}"/>
              </a:ext>
            </a:extLst>
          </p:cNvPr>
          <p:cNvSpPr txBox="1"/>
          <p:nvPr/>
        </p:nvSpPr>
        <p:spPr>
          <a:xfrm>
            <a:off x="4135116" y="697251"/>
            <a:ext cx="2036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of gene </a:t>
            </a:r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endParaRPr lang="es-E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312CDD4D-9931-1040-8847-8BA9F311DC04}"/>
              </a:ext>
            </a:extLst>
          </p:cNvPr>
          <p:cNvSpPr txBox="1"/>
          <p:nvPr/>
        </p:nvSpPr>
        <p:spPr>
          <a:xfrm>
            <a:off x="3553312" y="1066517"/>
            <a:ext cx="150733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0775F8CF-2396-E346-95E3-CD15F4C432A0}"/>
              </a:ext>
            </a:extLst>
          </p:cNvPr>
          <p:cNvSpPr txBox="1"/>
          <p:nvPr/>
        </p:nvSpPr>
        <p:spPr>
          <a:xfrm rot="16200000">
            <a:off x="692800" y="1773235"/>
            <a:ext cx="13195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of</a:t>
            </a:r>
          </a:p>
          <a:p>
            <a:pPr algn="ctr"/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gene </a:t>
            </a:r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endParaRPr lang="es-E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09A9A3ED-4FFC-AB4C-9C8E-95D4149BD0E5}"/>
              </a:ext>
            </a:extLst>
          </p:cNvPr>
          <p:cNvSpPr txBox="1"/>
          <p:nvPr/>
        </p:nvSpPr>
        <p:spPr>
          <a:xfrm>
            <a:off x="5189776" y="1066517"/>
            <a:ext cx="167501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No m</a:t>
            </a:r>
            <a:r>
              <a:rPr lang="es-E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D4DBEFBD-36BE-9744-9AD0-81AFABEEAF88}"/>
              </a:ext>
            </a:extLst>
          </p:cNvPr>
          <p:cNvSpPr txBox="1"/>
          <p:nvPr/>
        </p:nvSpPr>
        <p:spPr>
          <a:xfrm>
            <a:off x="1697791" y="1525815"/>
            <a:ext cx="18698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AB3D081-2701-A144-B55A-6D4A1ED42617}"/>
              </a:ext>
            </a:extLst>
          </p:cNvPr>
          <p:cNvSpPr txBox="1"/>
          <p:nvPr/>
        </p:nvSpPr>
        <p:spPr>
          <a:xfrm>
            <a:off x="1697791" y="1994591"/>
            <a:ext cx="18698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No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chang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9D71F9A4-96AD-D94D-97E9-0E89D54B1928}"/>
              </a:ext>
            </a:extLst>
          </p:cNvPr>
          <p:cNvSpPr txBox="1"/>
          <p:nvPr/>
        </p:nvSpPr>
        <p:spPr>
          <a:xfrm>
            <a:off x="491877" y="52797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21" name="Tabla 3">
            <a:extLst>
              <a:ext uri="{FF2B5EF4-FFF2-40B4-BE49-F238E27FC236}">
                <a16:creationId xmlns:a16="http://schemas.microsoft.com/office/drawing/2014/main" id="{79106B30-E951-7349-8FC1-F78DD643716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217783"/>
              </p:ext>
            </p:extLst>
          </p:nvPr>
        </p:nvGraphicFramePr>
        <p:xfrm>
          <a:off x="3534360" y="3974479"/>
          <a:ext cx="3237646" cy="89131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18823">
                  <a:extLst>
                    <a:ext uri="{9D8B030D-6E8A-4147-A177-3AD203B41FA5}">
                      <a16:colId xmlns:a16="http://schemas.microsoft.com/office/drawing/2014/main" val="2907900482"/>
                    </a:ext>
                  </a:extLst>
                </a:gridCol>
                <a:gridCol w="1618823">
                  <a:extLst>
                    <a:ext uri="{9D8B030D-6E8A-4147-A177-3AD203B41FA5}">
                      <a16:colId xmlns:a16="http://schemas.microsoft.com/office/drawing/2014/main" val="2535064530"/>
                    </a:ext>
                  </a:extLst>
                </a:gridCol>
              </a:tblGrid>
              <a:tr h="44565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46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6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05272359"/>
                  </a:ext>
                </a:extLst>
              </a:tr>
              <a:tr h="44565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6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s-E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6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2400017"/>
                  </a:ext>
                </a:extLst>
              </a:tr>
            </a:tbl>
          </a:graphicData>
        </a:graphic>
      </p:graphicFrame>
      <p:sp>
        <p:nvSpPr>
          <p:cNvPr id="22" name="CuadroTexto 21">
            <a:extLst>
              <a:ext uri="{FF2B5EF4-FFF2-40B4-BE49-F238E27FC236}">
                <a16:creationId xmlns:a16="http://schemas.microsoft.com/office/drawing/2014/main" id="{3C5DDA8E-9769-B54E-9A4B-64C610D530B1}"/>
              </a:ext>
            </a:extLst>
          </p:cNvPr>
          <p:cNvSpPr txBox="1"/>
          <p:nvPr/>
        </p:nvSpPr>
        <p:spPr>
          <a:xfrm>
            <a:off x="4135116" y="3111468"/>
            <a:ext cx="2036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of gene </a:t>
            </a:r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endParaRPr lang="es-E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4F45495C-72D2-1041-A98D-AE88BF5B5D6B}"/>
              </a:ext>
            </a:extLst>
          </p:cNvPr>
          <p:cNvSpPr txBox="1"/>
          <p:nvPr/>
        </p:nvSpPr>
        <p:spPr>
          <a:xfrm>
            <a:off x="3549145" y="3480734"/>
            <a:ext cx="15131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F2097DD7-E233-2546-BD56-CBCA4A06BC84}"/>
              </a:ext>
            </a:extLst>
          </p:cNvPr>
          <p:cNvSpPr txBox="1"/>
          <p:nvPr/>
        </p:nvSpPr>
        <p:spPr>
          <a:xfrm rot="16200000">
            <a:off x="691517" y="4187452"/>
            <a:ext cx="13195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of</a:t>
            </a:r>
          </a:p>
          <a:p>
            <a:pPr algn="ctr"/>
            <a:r>
              <a:rPr lang="es-ES" sz="1200" u="sng" dirty="0">
                <a:latin typeface="Arial" panose="020B0604020202020204" pitchFamily="34" charset="0"/>
                <a:cs typeface="Arial" panose="020B0604020202020204" pitchFamily="34" charset="0"/>
              </a:rPr>
              <a:t> gene </a:t>
            </a:r>
            <a:r>
              <a:rPr lang="es-ES" sz="1200" u="sng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endParaRPr lang="es-ES" sz="12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A198A311-E5AB-4F41-AF6E-B94011DE8124}"/>
              </a:ext>
            </a:extLst>
          </p:cNvPr>
          <p:cNvSpPr txBox="1"/>
          <p:nvPr/>
        </p:nvSpPr>
        <p:spPr>
          <a:xfrm>
            <a:off x="5243796" y="3480734"/>
            <a:ext cx="156440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s-E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decreas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BAD19F71-58F1-7D4A-90B9-709B7EC83327}"/>
              </a:ext>
            </a:extLst>
          </p:cNvPr>
          <p:cNvSpPr txBox="1"/>
          <p:nvPr/>
        </p:nvSpPr>
        <p:spPr>
          <a:xfrm>
            <a:off x="1696509" y="3940032"/>
            <a:ext cx="18698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FEEA066E-BB43-6242-8A76-4F8785899BEC}"/>
              </a:ext>
            </a:extLst>
          </p:cNvPr>
          <p:cNvSpPr txBox="1"/>
          <p:nvPr/>
        </p:nvSpPr>
        <p:spPr>
          <a:xfrm>
            <a:off x="1696509" y="4408808"/>
            <a:ext cx="18698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decreas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ion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endParaRPr lang="es-ES" sz="1200" dirty="0"/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4B3DE3F0-4FAE-CE40-9A4E-B1B433E1518E}"/>
              </a:ext>
            </a:extLst>
          </p:cNvPr>
          <p:cNvSpPr txBox="1"/>
          <p:nvPr/>
        </p:nvSpPr>
        <p:spPr>
          <a:xfrm>
            <a:off x="491877" y="294219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48B8B6A8-2C9B-C648-B49C-B98E6AC05C2F}"/>
              </a:ext>
            </a:extLst>
          </p:cNvPr>
          <p:cNvSpPr txBox="1"/>
          <p:nvPr/>
        </p:nvSpPr>
        <p:spPr>
          <a:xfrm>
            <a:off x="6704714" y="1784776"/>
            <a:ext cx="17127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Fisher´s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exact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test</a:t>
            </a:r>
          </a:p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2-sided P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= 0.78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04C544D2-D2D7-144D-A885-20A933A02536}"/>
              </a:ext>
            </a:extLst>
          </p:cNvPr>
          <p:cNvSpPr txBox="1"/>
          <p:nvPr/>
        </p:nvSpPr>
        <p:spPr>
          <a:xfrm>
            <a:off x="6704714" y="4198993"/>
            <a:ext cx="17127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Fisher´s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exact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test</a:t>
            </a:r>
          </a:p>
          <a:p>
            <a:pPr algn="ctr"/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2-sided P </a:t>
            </a:r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value</a:t>
            </a:r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 = 0.29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D03376BA-9894-1648-91B0-E7760C77DD36}"/>
              </a:ext>
            </a:extLst>
          </p:cNvPr>
          <p:cNvSpPr txBox="1"/>
          <p:nvPr/>
        </p:nvSpPr>
        <p:spPr>
          <a:xfrm>
            <a:off x="652338" y="5218431"/>
            <a:ext cx="7747119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ntegrat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of m</a:t>
            </a:r>
            <a:r>
              <a:rPr lang="es-E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A-seq and gene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data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ifferentiate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loss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of m</a:t>
            </a:r>
            <a:r>
              <a:rPr lang="es-E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arks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existing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ue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to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ntrolled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RNA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odificat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vs gene </a:t>
            </a:r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Fisher´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ac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test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hang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in m</a:t>
            </a:r>
            <a:r>
              <a:rPr lang="es-E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en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vs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at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2,410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ou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of the total 3,056+326 m</a:t>
            </a:r>
            <a:r>
              <a:rPr lang="es-E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A-seq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hibit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microarray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Fisher´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ac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test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betwee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drecreas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of m</a:t>
            </a:r>
            <a:r>
              <a:rPr lang="es-E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en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vs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up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at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Both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s-E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gai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loss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region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observ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in 120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hu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, 1,934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overlapping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m</a:t>
            </a:r>
            <a:r>
              <a:rPr lang="es-E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A-seq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microarray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onsider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Microarray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data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ollect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GEO (GSE44700) and differentially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gene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onsider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FDR &lt; 0.05 as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hreshol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7554074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2</TotalTime>
  <Words>236</Words>
  <Application>Microsoft Office PowerPoint</Application>
  <PresentationFormat>Presentación en pantalla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anel Esteller</cp:lastModifiedBy>
  <cp:revision>40</cp:revision>
  <dcterms:created xsi:type="dcterms:W3CDTF">2022-04-01T17:23:33Z</dcterms:created>
  <dcterms:modified xsi:type="dcterms:W3CDTF">2022-04-05T17:48:16Z</dcterms:modified>
</cp:coreProperties>
</file>